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86AEDF"/>
    <a:srgbClr val="D2645E"/>
    <a:srgbClr val="919191"/>
    <a:srgbClr val="EFBE04"/>
    <a:srgbClr val="4D9E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C92C92-3E5B-4E80-87A4-9F823522CF6F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FA9154-48BA-4AC8-9255-E492BAB21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2980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000BA55E-549C-1434-12D2-FD11A88E89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="" xmlns:a16="http://schemas.microsoft.com/office/drawing/2014/main" id="{DC6089F8-1D2B-575E-6A31-42E3D14CD8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55FE2E95-4093-89F8-A276-57FC2409C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1B15F7F1-62BA-D9C6-AB89-C52CF7D47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CF666B4E-8731-0ACD-964C-258BA9FD9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811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581DD438-CA55-7555-FD65-6CEA8B1D98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2C7C9719-9264-CAC7-0441-928555BD93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15FE70D1-673E-5A03-E28C-BD4AF202A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E2D69D2E-BB61-F675-5A05-2A98DC9E7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C4292E00-CD37-3E32-5CE4-D2FCA7E4C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3157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="" xmlns:a16="http://schemas.microsoft.com/office/drawing/2014/main" id="{1C33CBAA-FBED-563A-EC6D-E0EB2E9196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E8AA7AF3-F3F7-A678-DBF5-1D863448DC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12D138E0-D40E-D43E-E480-4524034B25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1A467D59-3BDB-6B8C-9272-7E0DFCE9B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E6B43392-AC01-7715-233C-3C9355002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5733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A4B3AF2B-63A3-F5D2-37BC-DFA4813EF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2D2BEBD8-D992-167C-F23A-11042EB3C8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A01D684D-ACAC-680C-9BCE-6671E3BCC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69219FB0-92A5-2147-1C86-17E66E9F0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D6FFE0C5-B4BA-2C23-F3CB-C751E53FEB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4095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A959ED28-0845-BCA1-1C08-AD76217C5D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8D8AD9EA-FA4B-B1E0-1B66-92F20CB9DC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2B740475-08F8-7278-55A2-4C3FA0B93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06FB0F8F-DE72-A804-97CF-784594150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AFDE9E41-9567-9959-95F2-A43BAE832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1849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811EA79C-9A72-33F1-5444-B9610F39D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7EB69DC5-91F0-E73F-3C1F-C938158260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68189593-778A-FCC4-4D40-63926014BE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CD0A9199-AB25-E08B-6B63-DFB24BF83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E808B5CC-A25E-F229-AC27-43EAF776D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1C581575-9E58-0EA4-D5BC-EC98062A2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6894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52493BA8-A5C5-8DE2-500F-825348A6F7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1FDEC504-6E2E-F95A-43D3-34317AC985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5B7C86CB-A32C-0054-38E4-0DD02B8A7B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="" xmlns:a16="http://schemas.microsoft.com/office/drawing/2014/main" id="{8F1D0AC3-FF9F-8822-22BB-FFA1DEA7CD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="" xmlns:a16="http://schemas.microsoft.com/office/drawing/2014/main" id="{D414E02D-5F4F-A13E-5C62-E33F021186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="" xmlns:a16="http://schemas.microsoft.com/office/drawing/2014/main" id="{19EFA593-6A7C-0F97-6EF3-608D34B11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="" xmlns:a16="http://schemas.microsoft.com/office/drawing/2014/main" id="{EC3CBF13-486D-9F1D-AFD2-2531E5715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="" xmlns:a16="http://schemas.microsoft.com/office/drawing/2014/main" id="{BEB1D0A7-370B-70ED-9FC0-2ECF68EEE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4919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0E2050DD-7DBC-0994-CD03-1239E876D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="" xmlns:a16="http://schemas.microsoft.com/office/drawing/2014/main" id="{8FDF136D-090E-2C21-68ED-0022195191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="" xmlns:a16="http://schemas.microsoft.com/office/drawing/2014/main" id="{EC296325-BD62-EBE9-392D-7591E44AE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="" xmlns:a16="http://schemas.microsoft.com/office/drawing/2014/main" id="{D07D422B-E7F5-CA85-C4EB-1BB8FC782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8079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="" xmlns:a16="http://schemas.microsoft.com/office/drawing/2014/main" id="{56322CB6-0EC1-FE68-80DD-1B7B31029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="" xmlns:a16="http://schemas.microsoft.com/office/drawing/2014/main" id="{1FD7E45E-498B-E223-A94E-72000BBEE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="" xmlns:a16="http://schemas.microsoft.com/office/drawing/2014/main" id="{B1BC6ADC-5D96-96DD-D088-785AAD9923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489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B5D51AE4-989D-E2AA-EB1B-7678F8AF97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65E54F76-53F1-F7DC-69D7-9ED085993A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62515FE0-EB76-ADCD-864F-3BCC68C73F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AC37D0C1-FB05-42DD-9B25-19DFB4A15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0A133603-07E4-C326-B2F8-B5BD86D05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4880C0FD-372A-04EF-9D8E-EC9BFC2D8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2515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6762FCFD-377C-7D06-361E-1D8C1DF361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="" xmlns:a16="http://schemas.microsoft.com/office/drawing/2014/main" id="{9DA1A130-1632-428D-1B66-0A8A96A00D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73E72691-59C4-F5F9-9B4C-634FDA18DA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175BAB6C-5AB1-C624-2C37-C6C2F344A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AD8A51BF-F029-43DC-A9E2-C26034B87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50DDB564-BE76-EDA8-ED31-B83591712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9181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="" xmlns:a16="http://schemas.microsoft.com/office/drawing/2014/main" id="{359850C6-3328-623D-D4D7-6CE72C65FC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BE7B27D3-FC50-59CF-E52C-5C07DCB50D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6665F665-5916-6493-775C-D73F3A1E8E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479C9A-BF40-4055-A093-B54B404A2462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89A47545-EC67-44B0-8625-A147428DB3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9D7D52DB-CDE2-A03F-B2BC-FA3A4506BA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C671EAA-F9CF-427A-AFEA-1FCE6287C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393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="" xmlns:a16="http://schemas.microsoft.com/office/drawing/2014/main" id="{DFEE94EF-4FB9-4EB7-210D-0A50368B7C94}"/>
              </a:ext>
            </a:extLst>
          </p:cNvPr>
          <p:cNvGrpSpPr/>
          <p:nvPr/>
        </p:nvGrpSpPr>
        <p:grpSpPr>
          <a:xfrm>
            <a:off x="3178630" y="587950"/>
            <a:ext cx="6984769" cy="3432749"/>
            <a:chOff x="2381865" y="13630319"/>
            <a:chExt cx="6984769" cy="3432749"/>
          </a:xfrm>
        </p:grpSpPr>
        <p:sp>
          <p:nvSpPr>
            <p:cNvPr id="5" name="四角形: 角を丸くする 4">
              <a:extLst>
                <a:ext uri="{FF2B5EF4-FFF2-40B4-BE49-F238E27FC236}">
                  <a16:creationId xmlns="" xmlns:a16="http://schemas.microsoft.com/office/drawing/2014/main" id="{FDFA9FCB-E176-E653-2FFF-2BDB2494B200}"/>
                </a:ext>
              </a:extLst>
            </p:cNvPr>
            <p:cNvSpPr/>
            <p:nvPr/>
          </p:nvSpPr>
          <p:spPr>
            <a:xfrm>
              <a:off x="2381865" y="13630319"/>
              <a:ext cx="2601684" cy="629920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kumimoji="1"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ollment </a:t>
              </a:r>
            </a:p>
            <a:p>
              <a:pPr algn="ctr"/>
              <a:r>
                <a:rPr kumimoji="1"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5</a:t>
              </a:r>
              <a:endParaRPr kumimoji="1" lang="ja-JP" alt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四角形: 角を丸くする 5">
              <a:extLst>
                <a:ext uri="{FF2B5EF4-FFF2-40B4-BE49-F238E27FC236}">
                  <a16:creationId xmlns="" xmlns:a16="http://schemas.microsoft.com/office/drawing/2014/main" id="{D99CFDBD-1994-A773-6827-80707532351C}"/>
                </a:ext>
              </a:extLst>
            </p:cNvPr>
            <p:cNvSpPr/>
            <p:nvPr/>
          </p:nvSpPr>
          <p:spPr>
            <a:xfrm>
              <a:off x="2481165" y="16433148"/>
              <a:ext cx="2406220" cy="629920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ull</a:t>
              </a:r>
              <a:r>
                <a:rPr lang="ja-JP" altLang="en-U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  <a:r>
                <a:rPr lang="ja-JP" altLang="en-U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t </a:t>
              </a:r>
            </a:p>
            <a:p>
              <a:pPr algn="ctr"/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= 294</a:t>
              </a:r>
              <a:endParaRPr kumimoji="1" lang="ja-JP" alt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線矢印コネクタ 6">
              <a:extLst>
                <a:ext uri="{FF2B5EF4-FFF2-40B4-BE49-F238E27FC236}">
                  <a16:creationId xmlns="" xmlns:a16="http://schemas.microsoft.com/office/drawing/2014/main" id="{6163F7D0-822B-D268-8B20-44B6C9C6262B}"/>
                </a:ext>
              </a:extLst>
            </p:cNvPr>
            <p:cNvCxnSpPr>
              <a:cxnSpLocks/>
            </p:cNvCxnSpPr>
            <p:nvPr/>
          </p:nvCxnSpPr>
          <p:spPr>
            <a:xfrm>
              <a:off x="3684275" y="14260239"/>
              <a:ext cx="0" cy="217290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四角形: 角を丸くする 7">
              <a:extLst>
                <a:ext uri="{FF2B5EF4-FFF2-40B4-BE49-F238E27FC236}">
                  <a16:creationId xmlns="" xmlns:a16="http://schemas.microsoft.com/office/drawing/2014/main" id="{BDDBBFE3-E7DC-0FBC-F174-953D4A8C0254}"/>
                </a:ext>
              </a:extLst>
            </p:cNvPr>
            <p:cNvSpPr/>
            <p:nvPr/>
          </p:nvSpPr>
          <p:spPr>
            <a:xfrm>
              <a:off x="4847717" y="14535700"/>
              <a:ext cx="4518917" cy="1388304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eligible: N</a:t>
              </a:r>
              <a:r>
                <a:rPr kumimoji="1"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= 11</a:t>
              </a:r>
            </a:p>
            <a:p>
              <a:r>
                <a:rPr lang="ja-JP" altLang="en-U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kumimoji="1"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st supportive care: N = 8</a:t>
              </a:r>
            </a:p>
            <a:p>
              <a:r>
                <a:rPr lang="ja-JP" altLang="en-U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</a:t>
              </a:r>
              <a:r>
                <a:rPr lang="ja-JP" altLang="en-U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stological</a:t>
              </a:r>
              <a:r>
                <a:rPr lang="ja-JP" altLang="en-U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firmation: N = 2</a:t>
              </a:r>
              <a:endPara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ja-JP" altLang="en-U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kumimoji="1"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ther regimen: 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kumimoji="1"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= 1</a:t>
              </a:r>
              <a:endParaRPr kumimoji="1" lang="ja-JP" alt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線矢印コネクタ 8">
              <a:extLst>
                <a:ext uri="{FF2B5EF4-FFF2-40B4-BE49-F238E27FC236}">
                  <a16:creationId xmlns="" xmlns:a16="http://schemas.microsoft.com/office/drawing/2014/main" id="{02D3924C-875E-DFB4-56C1-0B38CE9E48E2}"/>
                </a:ext>
              </a:extLst>
            </p:cNvPr>
            <p:cNvCxnSpPr>
              <a:cxnSpLocks/>
            </p:cNvCxnSpPr>
            <p:nvPr/>
          </p:nvCxnSpPr>
          <p:spPr>
            <a:xfrm>
              <a:off x="3684275" y="15203243"/>
              <a:ext cx="107067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テキスト ボックス 14">
            <a:extLst>
              <a:ext uri="{FF2B5EF4-FFF2-40B4-BE49-F238E27FC236}">
                <a16:creationId xmlns="" xmlns:a16="http://schemas.microsoft.com/office/drawing/2014/main" id="{C1F67B41-0115-92BF-5E9B-CE1C93A9D7CC}"/>
              </a:ext>
            </a:extLst>
          </p:cNvPr>
          <p:cNvSpPr txBox="1"/>
          <p:nvPr/>
        </p:nvSpPr>
        <p:spPr>
          <a:xfrm>
            <a:off x="3436012" y="4057045"/>
            <a:ext cx="2781531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em+CDDP+S-1: N = 75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em+CDDP: N = 131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em+S-1: N = 26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em: N = 52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-1: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= 10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="" xmlns:a16="http://schemas.microsoft.com/office/drawing/2014/main" id="{AC9D69F2-BB8B-C02B-5E7E-A66B9DBC36FF}"/>
              </a:ext>
            </a:extLst>
          </p:cNvPr>
          <p:cNvSpPr txBox="1"/>
          <p:nvPr/>
        </p:nvSpPr>
        <p:spPr>
          <a:xfrm>
            <a:off x="397566" y="120811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.</a:t>
            </a:r>
          </a:p>
        </p:txBody>
      </p:sp>
    </p:spTree>
    <p:extLst>
      <p:ext uri="{BB962C8B-B14F-4D97-AF65-F5344CB8AC3E}">
        <p14:creationId xmlns:p14="http://schemas.microsoft.com/office/powerpoint/2010/main" val="10402737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</TotalTime>
  <Words>44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toshi kobayashi</dc:creator>
  <cp:lastModifiedBy>Dhivya Kathirvel</cp:lastModifiedBy>
  <cp:revision>10</cp:revision>
  <dcterms:created xsi:type="dcterms:W3CDTF">2025-02-11T13:41:18Z</dcterms:created>
  <dcterms:modified xsi:type="dcterms:W3CDTF">2025-08-29T14:12:10Z</dcterms:modified>
</cp:coreProperties>
</file>